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8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73E07D-3615-6F4B-D2A1-023A414E5F7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9FFCBBA-AACF-3D73-4066-6AF039E0F1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9EE817-05E1-9E56-37A5-91A6EEEAEC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679108-153F-930B-84AD-8BA09C2F7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D12CFC-5B26-D03E-EA7A-EECF0C6988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91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B33BCB-45E2-A99D-6DF0-5CADB5F4E8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47EC565-F901-A94E-C4BE-EF04C4D413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CF41B8-DF75-DCF3-DB15-F5D6AD8CE3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0F231C-F882-97DB-B189-0F67D4F6D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DEC1A1-097F-344F-097D-F2A3747EA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724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13C47C0-3792-A5FB-9096-38AAEB4FE6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40ADA9-0DD9-0AFF-E4C4-8301EDD778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EB5F37-157A-EDB0-A753-3D6A097FEA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CAF30D-738D-3A48-ACBE-8AED8606E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91AEF6-0D17-87DC-9F42-EB1E463B3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738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6104F8-ECBA-E351-CDF0-A991BD5A3C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CD3793-C695-8FFB-E394-4478BE41D1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9B687E-900B-4306-FDC7-0E5DED9D8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836AA7-9A8B-2129-721B-272BC0E11F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3B9E66-2498-E985-1B40-FFA971B1E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426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C1DDAE-943A-6FB1-56B8-E6DEBA2C07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485B82-D9A6-25D7-F913-F48C5BAA64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3B254F-8A09-AA7F-E968-17795BAD1D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76A34D-9A69-7EDC-8DDF-6C6563B50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91CA67-CBC9-CB70-4CAB-C1B3B2DA7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8647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13CEAE-CEC9-2C4E-9B51-AEC02014AF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1B2BDE-3446-0E02-E600-AD38E9D39A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9935CB-AF17-D550-20C3-F73F642DCE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1AD69F-1843-CDCF-B1DC-75FEAC82E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347780-EF18-938D-033B-BE5D40AEF8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6DA85E-B41B-598C-B8A9-59E4E41A7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892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8C0465-4D45-5983-E544-DCE56BD294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2A52F6-923E-E8DA-14A5-6A7F3D98A0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B30D10-99AC-EF3D-ADD2-464826A588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BDEB659-20AC-08DB-135C-5820212678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2090872-C0FE-6770-DFE1-BD9CCA71B0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A48CFD-DED4-8C3C-54BF-B769B8E495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A2094E2-7648-61CF-B35F-E3EDC2074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8BC21EE-E4D6-5E5E-E237-362F512C4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560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35AF8B-B8E0-5DF3-DE0F-12497DF20D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001E304-1682-C8A6-754B-6411CACCB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CB45FD4-7848-23DD-C98F-60036611C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B160A66-31B2-7FC8-CB14-6720393B23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2928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512DA9-C0D3-C099-379B-45F5C44FAD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30048A-076A-7152-9B0F-CC5C82F647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419A92-8A9D-4109-6853-4A4C6341B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965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1BE5DB-147E-36E5-AD32-96D616591B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DA9E70-74C1-B573-CE04-B0030520A1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4917B3-536E-E9B9-099E-41D2C5DB0B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14EE4D-7235-C7AB-E8E7-F7F5DBD9A1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B23BF8-D9AB-91CC-6ECB-3DE7BD872A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140889-C89B-C4BF-F15A-C7A0512DD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752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F146DC-3863-9EEB-0F4C-79EF7EA7C4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604612-7C23-6CD8-8C84-41381A8F67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F8EEE7D-03CE-A3E5-AD01-C15AF033BE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B1F184-1A42-A466-6064-AC5B382F7B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F6035E-4416-F3F6-3759-FCA4DD1528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8F3048-45FF-9C25-506E-17E6918566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915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FFB2FD9-4C48-CC83-0C5B-3CA0F8BAF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87B79C-0BC4-FBF2-AAEB-1023883E6E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416921-23BA-6DE4-54B4-281025F629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3E12B7-E81D-7340-A586-827B154CEE15}" type="datetimeFigureOut">
              <a:rPr lang="en-US" smtClean="0"/>
              <a:t>6/1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824A5B-FF0C-D99F-C978-4163F3C27F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1FCF0A-383D-AAA3-1AD6-E1E5FD67D0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B9D470-1C39-F549-BAA7-AB07AEFEE4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80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graph&#10;&#10;AI-generated content may be incorrect.">
            <a:extLst>
              <a:ext uri="{FF2B5EF4-FFF2-40B4-BE49-F238E27FC236}">
                <a16:creationId xmlns:a16="http://schemas.microsoft.com/office/drawing/2014/main" id="{646DC823-51A9-A56A-0439-C9AB269B49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3148" y="631771"/>
            <a:ext cx="6410484" cy="495363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FEE6562-5CB1-78A1-6EF8-300208F8E422}"/>
              </a:ext>
            </a:extLst>
          </p:cNvPr>
          <p:cNvSpPr txBox="1"/>
          <p:nvPr/>
        </p:nvSpPr>
        <p:spPr>
          <a:xfrm>
            <a:off x="2889364" y="286225"/>
            <a:ext cx="6416886" cy="53841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38100" tIns="19050" rIns="38100" bIns="1905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1083" b="1" dirty="0">
                <a:ea typeface="Calibri"/>
                <a:cs typeface="Calibri"/>
              </a:rPr>
              <a:t>Supplemental Table S2:</a:t>
            </a:r>
            <a:r>
              <a:rPr lang="en-US" sz="1083" dirty="0">
                <a:ea typeface="Calibri"/>
                <a:cs typeface="Calibri"/>
              </a:rPr>
              <a:t>   </a:t>
            </a:r>
            <a:r>
              <a:rPr lang="en-US" sz="1083" dirty="0">
                <a:ea typeface="+mn-lt"/>
                <a:cs typeface="+mn-lt"/>
              </a:rPr>
              <a:t>Association of irAE with time-to-event outcomes of mortality or disease progression using adjusted hazard ratios and 95% confidence intervals, HR (95% CI), N=100 melanoma patients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8D00898-35E3-B763-F987-217ABD1E8B9A}"/>
              </a:ext>
            </a:extLst>
          </p:cNvPr>
          <p:cNvSpPr txBox="1"/>
          <p:nvPr/>
        </p:nvSpPr>
        <p:spPr>
          <a:xfrm>
            <a:off x="2880360" y="5587999"/>
            <a:ext cx="6548120" cy="615553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38100" tIns="19050" rIns="38100" bIns="1905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750" baseline="30000" dirty="0">
                <a:ea typeface="+mn-lt"/>
                <a:cs typeface="+mn-lt"/>
              </a:rPr>
              <a:t>1</a:t>
            </a:r>
            <a:r>
              <a:rPr lang="en-US" sz="750" dirty="0">
                <a:ea typeface="+mn-lt"/>
                <a:cs typeface="+mn-lt"/>
              </a:rPr>
              <a:t>Cox proportional hazards regression modeling time to outcome, adjusting for age, sex, and ICI therapy; </a:t>
            </a:r>
            <a:endParaRPr lang="en-US" sz="750" dirty="0"/>
          </a:p>
          <a:p>
            <a:r>
              <a:rPr lang="en-US" sz="750" baseline="30000" dirty="0">
                <a:ea typeface="+mn-lt"/>
                <a:cs typeface="+mn-lt"/>
              </a:rPr>
              <a:t>2</a:t>
            </a:r>
            <a:r>
              <a:rPr lang="en-US" sz="750" dirty="0">
                <a:ea typeface="+mn-lt"/>
                <a:cs typeface="+mn-lt"/>
              </a:rPr>
              <a:t>Addtionally adjusted for ECOG score (≥1 vs 0) and cancer stage (4 vs &lt;4); cancer stage did not meet PH assumption so that results are stratified by cancer stage. </a:t>
            </a:r>
            <a:endParaRPr lang="en-US" sz="750" dirty="0"/>
          </a:p>
          <a:p>
            <a:r>
              <a:rPr lang="en-US" sz="750" dirty="0">
                <a:ea typeface="+mn-lt"/>
                <a:cs typeface="+mn-lt"/>
              </a:rPr>
              <a:t>irAE are included as time-varying covariables </a:t>
            </a:r>
            <a:endParaRPr lang="en-US" sz="750" dirty="0"/>
          </a:p>
          <a:p>
            <a:r>
              <a:rPr lang="en-US" sz="750" dirty="0">
                <a:ea typeface="+mn-lt"/>
                <a:cs typeface="+mn-lt"/>
              </a:rPr>
              <a:t>significant results at alpha=0.05 are shown in bold</a:t>
            </a:r>
            <a:endParaRPr lang="en-US" sz="750" dirty="0"/>
          </a:p>
        </p:txBody>
      </p:sp>
    </p:spTree>
    <p:extLst>
      <p:ext uri="{BB962C8B-B14F-4D97-AF65-F5344CB8AC3E}">
        <p14:creationId xmlns:p14="http://schemas.microsoft.com/office/powerpoint/2010/main" val="21288034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unningham, Michael Montana</dc:creator>
  <cp:lastModifiedBy>MDPI</cp:lastModifiedBy>
  <cp:revision>2</cp:revision>
  <dcterms:created xsi:type="dcterms:W3CDTF">2025-06-16T16:54:17Z</dcterms:created>
  <dcterms:modified xsi:type="dcterms:W3CDTF">2025-06-17T03:51:48Z</dcterms:modified>
</cp:coreProperties>
</file>